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  <p:sldId id="264" r:id="rId3"/>
    <p:sldId id="274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6" autoAdjust="0"/>
    <p:restoredTop sz="94660"/>
  </p:normalViewPr>
  <p:slideViewPr>
    <p:cSldViewPr snapToGrid="0">
      <p:cViewPr varScale="1">
        <p:scale>
          <a:sx n="86" d="100"/>
          <a:sy n="86" d="100"/>
        </p:scale>
        <p:origin x="48" y="12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172EE7-7C5C-8B1A-81C2-2B2CB35BE5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4E0514F-9292-6144-A513-71D9C5617E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AFCE21-BAF9-5081-5BC4-34E8986F5A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AB63-781E-6040-B672-B536BCA5AB5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B1ABF2B-7A31-1858-9F44-75CB6722A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282A58E-5879-D4DC-39B9-31D3E572D6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B43C9-8439-DB4B-B7E8-4229F672E8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88938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8186248-0859-06E0-B48F-522C2BCBA5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D6E1753-8E5E-79E7-B2E5-E358C2148B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284CEB6-8DAC-D66C-6B7C-03014D943B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AB63-781E-6040-B672-B536BCA5AB5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DC7D4A5-C6E0-2242-AB0F-2F242ECC0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A181C00-EF08-A74D-14C1-C4BA32F07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B43C9-8439-DB4B-B7E8-4229F672E8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604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749B290-EDCC-70C8-BDA2-A91479DA1A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D55C323-218E-1F33-C995-C5DD3F24B3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0B7AE9F-31FA-3909-15D6-334625F77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AB63-781E-6040-B672-B536BCA5AB5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281F8A4-2B95-CF65-7518-D0E770833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0397210-D6C2-FD9F-3396-CD537F538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B43C9-8439-DB4B-B7E8-4229F672E8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4231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CF4D10-65ED-7953-A885-AE34E3C337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837A534-2832-688D-FB2A-1234FBF88F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870662A-63EC-EB83-761D-2FDB9894E7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AB63-781E-6040-B672-B536BCA5AB5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447A730-035A-A3EA-FD74-B206AE5993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7436B5-44D8-333B-E75F-05FCF9148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B43C9-8439-DB4B-B7E8-4229F672E8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80931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9D8F4E-109B-3F47-BA8D-A1D4385092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2B93632-CAD8-FA4F-0C38-DF169622B6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AABD618-6D9C-5FB8-AC5C-1FDFBA804C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AB63-781E-6040-B672-B536BCA5AB5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3C936D1-8756-71B5-4E0B-6AC8C8B6F5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A444F67-7758-216D-E45B-E6BA2B00C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B43C9-8439-DB4B-B7E8-4229F672E8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6666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B01FF75-5437-32AD-02F8-4699833517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A01A98C-A6B1-8C62-08B1-E2B2A0CEFC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E10EBB7-284D-D4FB-DC62-3C4172FF2A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8C57D56-77ED-2A11-871D-4BD662A25D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AB63-781E-6040-B672-B536BCA5AB5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A07EA5E-2E7B-F6D5-CDD5-65078E3E9C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12DA422-4664-E021-AC1E-C89321277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B43C9-8439-DB4B-B7E8-4229F672E8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2631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F2BB2A6-B2DE-BCFA-163A-EF13E38F16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6CE181F-95DF-198F-C1D5-2D012FFF08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FACAC29-60F3-A380-FD0D-60F461AEA3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25F77AF-07E9-5CCD-4CA1-2760025760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35D2097-FC76-C2C3-3A0A-53BDCEE0CE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E35CFA7-A19E-0DC4-5544-BF9409DA4C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AB63-781E-6040-B672-B536BCA5AB5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4BB9419-2894-0C84-6F73-B8647FED52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1C4ADA5-F1F8-B0D6-96C1-D85B6A663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B43C9-8439-DB4B-B7E8-4229F672E8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9010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57316B-220C-AD34-5EA5-4C0283800C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7409CC1-8AA2-F155-79B7-FC0FBCC8B4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AB63-781E-6040-B672-B536BCA5AB5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70043D2-CB61-070F-4EDE-05DD56C726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ADE2A7C-BBE8-3AC3-02CB-207C2472D3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B43C9-8439-DB4B-B7E8-4229F672E8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2832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9E72641-EF05-8C6A-A5C6-D117817087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AB63-781E-6040-B672-B536BCA5AB5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93A5C2D-FB3E-B478-8486-4E6D5FF16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6CB1429-8D99-FC2C-2402-8D87F20DE9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B43C9-8439-DB4B-B7E8-4229F672E8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5389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AFDED9-4905-F096-A268-3320A55625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0AF1061-2AC8-8DF1-6D84-CEBF0B556E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26EC0B6-D89A-9B38-1188-7B21C0ECDA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67A2FDB-CF76-0071-3BE5-CD913CEB68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AB63-781E-6040-B672-B536BCA5AB5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AA72739-D4A8-B468-AC5B-31CA62F20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5E220CD-E2A2-32B2-D128-0906063DD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B43C9-8439-DB4B-B7E8-4229F672E8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22223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7E0219-908B-17E4-53B3-8F930A1A59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1927E2F-0F98-2B1D-853D-CA32E7A9E2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87ED887-B3C5-B1FB-34A5-80DD9BB3A8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9B85C75-10C6-94D6-A51B-7FA4DC10B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AB63-781E-6040-B672-B536BCA5AB5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E202098-BF11-AB83-EBAE-7AA180893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4E014C0-F75B-5F9D-C9A7-8DD279CDB0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B43C9-8439-DB4B-B7E8-4229F672E8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3557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EF7D5D9-0845-6BF7-8701-206C229907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8F287BE-FA8A-5B06-48D4-546AB4E58F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B5A63A5-8042-C8D5-8F7A-525BF9E6DF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BD2AB63-781E-6040-B672-B536BCA5AB5A}" type="datetimeFigureOut">
              <a:rPr kumimoji="1" lang="ja-JP" altLang="en-US" smtClean="0"/>
              <a:t>2025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38F7F8D-9DB8-A74C-4ABE-41252E990A1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7C4CC8-6C95-4E92-FD07-9EBEB65877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63B43C9-8439-DB4B-B7E8-4229F672E8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4634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940F538-629A-5B83-2F32-86F240252AE4}"/>
              </a:ext>
            </a:extLst>
          </p:cNvPr>
          <p:cNvSpPr txBox="1"/>
          <p:nvPr/>
        </p:nvSpPr>
        <p:spPr>
          <a:xfrm>
            <a:off x="185979" y="123987"/>
            <a:ext cx="33287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 Figure1</a:t>
            </a:r>
            <a:endParaRPr kumimoji="1" lang="ja-JP" altLang="en-US" sz="18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C50788C2-B5DA-3071-CA22-0A222A554A7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4254"/>
          <a:stretch>
            <a:fillRect/>
          </a:stretch>
        </p:blipFill>
        <p:spPr>
          <a:xfrm>
            <a:off x="2955235" y="290944"/>
            <a:ext cx="9120000" cy="65490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0134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F3E41E9C-F1DA-B497-9712-57E378DCCDA9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709530" y="1368520"/>
          <a:ext cx="9167855" cy="410238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4482164">
                  <a:extLst>
                    <a:ext uri="{9D8B030D-6E8A-4147-A177-3AD203B41FA5}">
                      <a16:colId xmlns:a16="http://schemas.microsoft.com/office/drawing/2014/main" val="2484436701"/>
                    </a:ext>
                  </a:extLst>
                </a:gridCol>
                <a:gridCol w="1739211">
                  <a:extLst>
                    <a:ext uri="{9D8B030D-6E8A-4147-A177-3AD203B41FA5}">
                      <a16:colId xmlns:a16="http://schemas.microsoft.com/office/drawing/2014/main" val="1729488724"/>
                    </a:ext>
                  </a:extLst>
                </a:gridCol>
                <a:gridCol w="1739211">
                  <a:extLst>
                    <a:ext uri="{9D8B030D-6E8A-4147-A177-3AD203B41FA5}">
                      <a16:colId xmlns:a16="http://schemas.microsoft.com/office/drawing/2014/main" val="3077764990"/>
                    </a:ext>
                  </a:extLst>
                </a:gridCol>
                <a:gridCol w="1207269">
                  <a:extLst>
                    <a:ext uri="{9D8B030D-6E8A-4147-A177-3AD203B41FA5}">
                      <a16:colId xmlns:a16="http://schemas.microsoft.com/office/drawing/2014/main" val="3674690283"/>
                    </a:ext>
                  </a:extLst>
                </a:gridCol>
              </a:tblGrid>
              <a:tr h="455820">
                <a:tc>
                  <a:txBody>
                    <a:bodyPr/>
                    <a:lstStyle/>
                    <a:p>
                      <a:pPr algn="ctr" fontAlgn="b"/>
                      <a:r>
                        <a:rPr lang="en" sz="18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</a:t>
                      </a:r>
                      <a:endParaRPr lang="en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0" marB="7200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8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</a:t>
                      </a:r>
                      <a:endParaRPr lang="en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0" marB="7200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8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 CI</a:t>
                      </a:r>
                      <a:endParaRPr lang="en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0" marB="7200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18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0" marB="7200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6220708"/>
                  </a:ext>
                </a:extLst>
              </a:tr>
              <a:tr h="455820">
                <a:tc>
                  <a:txBody>
                    <a:bodyPr/>
                    <a:lstStyle/>
                    <a:p>
                      <a:pPr algn="l" fontAlgn="b"/>
                      <a:r>
                        <a:rPr lang="en" sz="18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eligible vs N1+ &gt;5cm</a:t>
                      </a:r>
                      <a:endParaRPr lang="en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9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9 (0.24–13.50)</a:t>
                      </a:r>
                    </a:p>
                  </a:txBody>
                  <a:tcPr marL="9525" marR="9525" marT="9525" marB="0" anchor="b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4</a:t>
                      </a:r>
                    </a:p>
                  </a:txBody>
                  <a:tcPr marL="9525" marR="9525" marT="9525" marB="0" anchor="b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065181858"/>
                  </a:ext>
                </a:extLst>
              </a:tr>
              <a:tr h="455820">
                <a:tc>
                  <a:txBody>
                    <a:bodyPr/>
                    <a:lstStyle/>
                    <a:p>
                      <a:pPr algn="l" fontAlgn="b"/>
                      <a:r>
                        <a:rPr lang="en" sz="18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eligible vs N1+ G3</a:t>
                      </a:r>
                      <a:endParaRPr lang="en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8 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8 (1.46–7.84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29943351"/>
                  </a:ext>
                </a:extLst>
              </a:tr>
              <a:tr h="455820">
                <a:tc>
                  <a:txBody>
                    <a:bodyPr/>
                    <a:lstStyle/>
                    <a:p>
                      <a:pPr algn="l" fontAlgn="b"/>
                      <a:r>
                        <a:rPr lang="en" altLang="ja-JP" sz="18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eligible</a:t>
                      </a:r>
                      <a:r>
                        <a:rPr lang="en" sz="18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s ≧N2</a:t>
                      </a:r>
                      <a:endParaRPr lang="en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9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9 (1.68–6.85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81628225"/>
                  </a:ext>
                </a:extLst>
              </a:tr>
              <a:tr h="455820">
                <a:tc>
                  <a:txBody>
                    <a:bodyPr/>
                    <a:lstStyle/>
                    <a:p>
                      <a:pPr algn="l" fontAlgn="b"/>
                      <a:r>
                        <a:rPr lang="en" sz="18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</a:t>
                      </a:r>
                      <a:r>
                        <a:rPr lang="e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 years </a:t>
                      </a:r>
                      <a:r>
                        <a:rPr lang="en" sz="18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&lt;65 VS 65≦）</a:t>
                      </a:r>
                      <a:endParaRPr lang="en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 (0.35–1.36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47299667"/>
                  </a:ext>
                </a:extLst>
              </a:tr>
              <a:tr h="455820">
                <a:tc>
                  <a:txBody>
                    <a:bodyPr/>
                    <a:lstStyle/>
                    <a:p>
                      <a:pPr algn="l" fontAlgn="b"/>
                      <a:r>
                        <a:rPr lang="en" sz="18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oadjuvant chemotherapy</a:t>
                      </a:r>
                      <a:endParaRPr lang="en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1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1 (1.42–5.19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8904349"/>
                  </a:ext>
                </a:extLst>
              </a:tr>
              <a:tr h="455820">
                <a:tc>
                  <a:txBody>
                    <a:bodyPr/>
                    <a:lstStyle/>
                    <a:p>
                      <a:pPr algn="l" fontAlgn="b"/>
                      <a:r>
                        <a:rPr lang="en" sz="18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juvant chemotherapy</a:t>
                      </a:r>
                      <a:endParaRPr lang="en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 (0.46–1.67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57159323"/>
                  </a:ext>
                </a:extLst>
              </a:tr>
              <a:tr h="455820">
                <a:tc>
                  <a:txBody>
                    <a:bodyPr/>
                    <a:lstStyle/>
                    <a:p>
                      <a:pPr algn="l" fontAlgn="b"/>
                      <a:r>
                        <a:rPr lang="en" sz="18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juvant radiation therapy</a:t>
                      </a:r>
                      <a:endParaRPr lang="en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4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0.65–2.00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2501054"/>
                  </a:ext>
                </a:extLst>
              </a:tr>
              <a:tr h="455820">
                <a:tc>
                  <a:txBody>
                    <a:bodyPr/>
                    <a:lstStyle/>
                    <a:p>
                      <a:pPr algn="l" fontAlgn="b"/>
                      <a:r>
                        <a:rPr lang="en" sz="18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menopausal vs </a:t>
                      </a:r>
                      <a:r>
                        <a:rPr lang="en" altLang="ja-JP" sz="1800" b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menoposal</a:t>
                      </a:r>
                      <a:endParaRPr lang="en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0.42–1.27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88103257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B30077D-51B6-2B45-DC0C-17B78BA932D0}"/>
              </a:ext>
            </a:extLst>
          </p:cNvPr>
          <p:cNvSpPr txBox="1"/>
          <p:nvPr/>
        </p:nvSpPr>
        <p:spPr>
          <a:xfrm>
            <a:off x="185980" y="123987"/>
            <a:ext cx="27429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 Table 1</a:t>
            </a:r>
            <a:endParaRPr kumimoji="1" lang="ja-JP" altLang="en-US" sz="18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01253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2AE1F022-F007-8A4A-81E1-823DF1FF06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286000"/>
            <a:ext cx="6096000" cy="4572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7FCDC598-CAEB-FEEA-A8C0-7B656FBDF9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2286000"/>
            <a:ext cx="6096000" cy="45720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DC646CD-D3CE-5445-D8CE-888E9F4BFD0F}"/>
              </a:ext>
            </a:extLst>
          </p:cNvPr>
          <p:cNvSpPr txBox="1"/>
          <p:nvPr/>
        </p:nvSpPr>
        <p:spPr>
          <a:xfrm>
            <a:off x="185979" y="123987"/>
            <a:ext cx="33287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 Figure 2</a:t>
            </a:r>
            <a:endParaRPr kumimoji="1" lang="ja-JP" altLang="en-US" sz="18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742E1A69-0ABB-3B31-6B80-FCF403608AC1}"/>
              </a:ext>
            </a:extLst>
          </p:cNvPr>
          <p:cNvGraphicFramePr>
            <a:graphicFrameLocks noGrp="1"/>
          </p:cNvGraphicFramePr>
          <p:nvPr/>
        </p:nvGraphicFramePr>
        <p:xfrm>
          <a:off x="1366404" y="4572000"/>
          <a:ext cx="2476500" cy="381000"/>
        </p:xfrm>
        <a:graphic>
          <a:graphicData uri="http://schemas.openxmlformats.org/drawingml/2006/table">
            <a:tbl>
              <a:tblPr/>
              <a:tblGrid>
                <a:gridCol w="825500">
                  <a:extLst>
                    <a:ext uri="{9D8B030D-6E8A-4147-A177-3AD203B41FA5}">
                      <a16:colId xmlns:a16="http://schemas.microsoft.com/office/drawing/2014/main" val="2604745591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2005796753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3146639218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_C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_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166406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9-18.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0197971"/>
                  </a:ext>
                </a:extLst>
              </a:tr>
            </a:tbl>
          </a:graphicData>
        </a:graphic>
      </p:graphicFrame>
      <p:graphicFrame>
        <p:nvGraphicFramePr>
          <p:cNvPr id="12" name="表 11">
            <a:extLst>
              <a:ext uri="{FF2B5EF4-FFF2-40B4-BE49-F238E27FC236}">
                <a16:creationId xmlns:a16="http://schemas.microsoft.com/office/drawing/2014/main" id="{CA4BD139-395E-762D-82E8-47639F4CC180}"/>
              </a:ext>
            </a:extLst>
          </p:cNvPr>
          <p:cNvGraphicFramePr>
            <a:graphicFrameLocks noGrp="1"/>
          </p:cNvGraphicFramePr>
          <p:nvPr/>
        </p:nvGraphicFramePr>
        <p:xfrm>
          <a:off x="7619423" y="4572000"/>
          <a:ext cx="2476500" cy="381000"/>
        </p:xfrm>
        <a:graphic>
          <a:graphicData uri="http://schemas.openxmlformats.org/drawingml/2006/table">
            <a:tbl>
              <a:tblPr/>
              <a:tblGrid>
                <a:gridCol w="825500">
                  <a:extLst>
                    <a:ext uri="{9D8B030D-6E8A-4147-A177-3AD203B41FA5}">
                      <a16:colId xmlns:a16="http://schemas.microsoft.com/office/drawing/2014/main" val="3412841806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86427646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3545043344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_C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_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847267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5-6.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&lt;0.0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2101693"/>
                  </a:ext>
                </a:extLst>
              </a:tr>
            </a:tbl>
          </a:graphicData>
        </a:graphic>
      </p:graphicFrame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E25C8C95-D998-D0AE-8BF7-02E87CFF263E}"/>
              </a:ext>
            </a:extLst>
          </p:cNvPr>
          <p:cNvSpPr/>
          <p:nvPr/>
        </p:nvSpPr>
        <p:spPr>
          <a:xfrm>
            <a:off x="185979" y="5880453"/>
            <a:ext cx="576021" cy="1587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11000402020202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A514E66-DFA0-D5D4-D1C7-BFD1D4550DAB}"/>
              </a:ext>
            </a:extLst>
          </p:cNvPr>
          <p:cNvSpPr/>
          <p:nvPr/>
        </p:nvSpPr>
        <p:spPr>
          <a:xfrm>
            <a:off x="375165" y="6256701"/>
            <a:ext cx="576021" cy="1587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11000402020202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212CD056-75CE-76D5-9E64-E045892427DF}"/>
              </a:ext>
            </a:extLst>
          </p:cNvPr>
          <p:cNvSpPr/>
          <p:nvPr/>
        </p:nvSpPr>
        <p:spPr>
          <a:xfrm>
            <a:off x="6281979" y="5880453"/>
            <a:ext cx="576021" cy="1587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11000402020202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B4B63B30-153E-5A47-D837-FF2D4C4375B7}"/>
              </a:ext>
            </a:extLst>
          </p:cNvPr>
          <p:cNvSpPr/>
          <p:nvPr/>
        </p:nvSpPr>
        <p:spPr>
          <a:xfrm>
            <a:off x="6471165" y="6236427"/>
            <a:ext cx="576021" cy="1587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11000402020202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004809720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2</Words>
  <Application>Microsoft Office PowerPoint</Application>
  <PresentationFormat>ワイド画面</PresentationFormat>
  <Paragraphs>51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0" baseType="lpstr">
      <vt:lpstr>ＭＳ Ｐゴシック</vt:lpstr>
      <vt:lpstr>游ゴシック</vt:lpstr>
      <vt:lpstr>游ゴシック Light</vt:lpstr>
      <vt:lpstr>Arial</vt:lpstr>
      <vt:lpstr>Calibri</vt:lpstr>
      <vt:lpstr>Times New Roman</vt:lpstr>
      <vt:lpstr>1_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moi Tatsunori（下井 辰徳）</dc:creator>
  <cp:lastModifiedBy>Shimoi Tatsunori（下井 辰徳）</cp:lastModifiedBy>
  <cp:revision>1</cp:revision>
  <dcterms:created xsi:type="dcterms:W3CDTF">2025-07-06T02:31:57Z</dcterms:created>
  <dcterms:modified xsi:type="dcterms:W3CDTF">2025-07-06T02:32:21Z</dcterms:modified>
</cp:coreProperties>
</file>